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CCFF"/>
    <a:srgbClr val="0000CC"/>
    <a:srgbClr val="D73027"/>
    <a:srgbClr val="FC8D59"/>
    <a:srgbClr val="FEE08B"/>
    <a:srgbClr val="FFFFBF"/>
    <a:srgbClr val="D9EF8B"/>
    <a:srgbClr val="1A9850"/>
    <a:srgbClr val="91CF6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 autoAdjust="0"/>
    <p:restoredTop sz="94629" autoAdjust="0"/>
  </p:normalViewPr>
  <p:slideViewPr>
    <p:cSldViewPr snapToGrid="0" snapToObjects="1">
      <p:cViewPr>
        <p:scale>
          <a:sx n="100" d="100"/>
          <a:sy n="100" d="100"/>
        </p:scale>
        <p:origin x="-426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916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385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581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648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134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448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784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743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326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981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187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5103C0-65E9-5D43-9038-71F6496856AB}" type="datetimeFigureOut">
              <a:rPr lang="en-US" smtClean="0"/>
              <a:t>5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195F-68DE-3C4B-9DFF-22B24D9DE8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033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2190750" y="19025"/>
            <a:ext cx="6858000" cy="6858000"/>
            <a:chOff x="2190750" y="19025"/>
            <a:chExt cx="6858000" cy="6858000"/>
          </a:xfrm>
        </p:grpSpPr>
        <p:pic>
          <p:nvPicPr>
            <p:cNvPr id="3" name="Picture 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90750" y="19025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CI_H82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90500" y="2321461"/>
            <a:ext cx="1508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sensi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89381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80486" y="0"/>
            <a:ext cx="6858000" cy="6858000"/>
            <a:chOff x="2180486" y="0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80486" y="0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IST_SL2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495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resist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1299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180486" y="0"/>
            <a:ext cx="6858000" cy="6858000"/>
            <a:chOff x="2180486" y="0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80486" y="0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CI_H446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508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sensi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8642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71700" y="0"/>
            <a:ext cx="6858000" cy="6858000"/>
            <a:chOff x="2171700" y="0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71700" y="0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CI_H526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508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sensi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23074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73251" y="13183"/>
            <a:ext cx="6858000" cy="6858000"/>
            <a:chOff x="2173251" y="13183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73251" y="13183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COR_L88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508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sensi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16186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78275" y="3658"/>
            <a:ext cx="6858000" cy="6858000"/>
            <a:chOff x="2178275" y="3658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78275" y="3658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IST_SL1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508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sensi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41769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80486" y="4236"/>
            <a:ext cx="6858000" cy="6858000"/>
            <a:chOff x="2180486" y="4236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80486" y="4236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DMS_114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495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resist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60363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81225" y="0"/>
            <a:ext cx="6858000" cy="6858000"/>
            <a:chOff x="2181225" y="0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81225" y="0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CI_H64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495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resist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1508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77385" y="4236"/>
            <a:ext cx="6858000" cy="6858000"/>
            <a:chOff x="2177385" y="4236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77385" y="4236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DMS_79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495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resist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52039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81225" y="4236"/>
            <a:ext cx="6858000" cy="6858000"/>
            <a:chOff x="2181225" y="4236"/>
            <a:chExt cx="6858000" cy="685800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181225" y="4236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 9"/>
            <p:cNvSpPr/>
            <p:nvPr/>
          </p:nvSpPr>
          <p:spPr>
            <a:xfrm>
              <a:off x="2793217" y="640273"/>
              <a:ext cx="5614967" cy="5615504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569867" y="1427493"/>
              <a:ext cx="4061667" cy="4051560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86726" y="545809"/>
              <a:ext cx="12279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Gene Express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1585" y="1348962"/>
              <a:ext cx="59823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/>
                <a:t>CNV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38036" y="4054475"/>
              <a:ext cx="461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4313737" y="2150536"/>
              <a:ext cx="2565428" cy="2565401"/>
            </a:xfrm>
            <a:prstGeom prst="ellipse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88276" y="2044462"/>
              <a:ext cx="82484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tations</a:t>
              </a:r>
            </a:p>
          </p:txBody>
        </p:sp>
        <p:sp>
          <p:nvSpPr>
            <p:cNvPr id="5" name="Oval 4"/>
            <p:cNvSpPr/>
            <p:nvPr/>
          </p:nvSpPr>
          <p:spPr>
            <a:xfrm>
              <a:off x="5207000" y="3035300"/>
              <a:ext cx="787401" cy="78740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01167" y="3290501"/>
              <a:ext cx="999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CI_H2171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35041" y="168405"/>
            <a:ext cx="1086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Gene Express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35926" y="768575"/>
            <a:ext cx="598231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N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56802" y="1180191"/>
            <a:ext cx="8248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utation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41" y="32233"/>
            <a:ext cx="1562100" cy="158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0500" y="2321461"/>
            <a:ext cx="1495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ug resist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5958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</TotalTime>
  <Words>110</Words>
  <Application>Microsoft Office PowerPoint</Application>
  <PresentationFormat>On-screen Show (4:3)</PresentationFormat>
  <Paragraphs>8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say Stetson</dc:creator>
  <cp:lastModifiedBy>Gary Wildey</cp:lastModifiedBy>
  <cp:revision>48</cp:revision>
  <cp:lastPrinted>2013-02-18T08:20:16Z</cp:lastPrinted>
  <dcterms:created xsi:type="dcterms:W3CDTF">2013-02-18T05:37:24Z</dcterms:created>
  <dcterms:modified xsi:type="dcterms:W3CDTF">2014-05-12T14:09:05Z</dcterms:modified>
</cp:coreProperties>
</file>